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custDataLst>
    <p:tags r:id="rId3"/>
  </p:custDataLst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9D74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9467" autoAdjust="0"/>
  </p:normalViewPr>
  <p:slideViewPr>
    <p:cSldViewPr>
      <p:cViewPr>
        <p:scale>
          <a:sx n="80" d="100"/>
          <a:sy n="80" d="100"/>
        </p:scale>
        <p:origin x="-696" y="1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caidas%204dictrabajando\Respuesta%20revisor\IPA%20and%20distribution%201998-200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IP BIMESTRAL'!$A$3</c:f>
              <c:strCache>
                <c:ptCount val="1"/>
                <c:pt idx="0">
                  <c:v>IPA (POB LOCALIDADES CON CASOS)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diamond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multiLvlStrRef>
              <c:f>'IP BIMESTRAL'!$B$1:$BL$2</c:f>
              <c:multiLvlStrCache>
                <c:ptCount val="63"/>
                <c:lvl>
                  <c:pt idx="0">
                    <c:v>Jan-Feb</c:v>
                  </c:pt>
                  <c:pt idx="1">
                    <c:v>Mar-Apr</c:v>
                  </c:pt>
                  <c:pt idx="2">
                    <c:v>May-Jun</c:v>
                  </c:pt>
                  <c:pt idx="3">
                    <c:v>Jul-aug</c:v>
                  </c:pt>
                  <c:pt idx="4">
                    <c:v>Sep-Oct</c:v>
                  </c:pt>
                  <c:pt idx="5">
                    <c:v>Nov-Dec</c:v>
                  </c:pt>
                  <c:pt idx="6">
                    <c:v>Jan-Feb</c:v>
                  </c:pt>
                  <c:pt idx="7">
                    <c:v>Mar-Apr</c:v>
                  </c:pt>
                  <c:pt idx="8">
                    <c:v>May-Jun</c:v>
                  </c:pt>
                  <c:pt idx="9">
                    <c:v>Jul-aug</c:v>
                  </c:pt>
                  <c:pt idx="10">
                    <c:v>Sep-Oct</c:v>
                  </c:pt>
                  <c:pt idx="11">
                    <c:v>Nov-Dec</c:v>
                  </c:pt>
                  <c:pt idx="12">
                    <c:v>Jan-Feb</c:v>
                  </c:pt>
                  <c:pt idx="13">
                    <c:v>Mar-Apr</c:v>
                  </c:pt>
                  <c:pt idx="14">
                    <c:v>May-Jun</c:v>
                  </c:pt>
                  <c:pt idx="15">
                    <c:v>Jul-aug</c:v>
                  </c:pt>
                  <c:pt idx="16">
                    <c:v>Sep-Oct</c:v>
                  </c:pt>
                  <c:pt idx="17">
                    <c:v>Nov-Dec</c:v>
                  </c:pt>
                  <c:pt idx="18">
                    <c:v>Jan-Feb</c:v>
                  </c:pt>
                  <c:pt idx="19">
                    <c:v>Mar-Apr</c:v>
                  </c:pt>
                  <c:pt idx="20">
                    <c:v>May-Jun</c:v>
                  </c:pt>
                  <c:pt idx="21">
                    <c:v>Jul-aug</c:v>
                  </c:pt>
                  <c:pt idx="22">
                    <c:v>Sep-Oct</c:v>
                  </c:pt>
                  <c:pt idx="23">
                    <c:v>Nov-Dec</c:v>
                  </c:pt>
                  <c:pt idx="24">
                    <c:v>Jan-Feb</c:v>
                  </c:pt>
                  <c:pt idx="25">
                    <c:v>Mar-Apr</c:v>
                  </c:pt>
                  <c:pt idx="26">
                    <c:v>May-Jun</c:v>
                  </c:pt>
                  <c:pt idx="27">
                    <c:v>Jul-aug</c:v>
                  </c:pt>
                  <c:pt idx="28">
                    <c:v>Sep-Oct</c:v>
                  </c:pt>
                  <c:pt idx="29">
                    <c:v>Nov-Dec</c:v>
                  </c:pt>
                  <c:pt idx="30">
                    <c:v>Jan-Feb</c:v>
                  </c:pt>
                  <c:pt idx="31">
                    <c:v>Mar-Apr</c:v>
                  </c:pt>
                  <c:pt idx="32">
                    <c:v>May-Jun</c:v>
                  </c:pt>
                  <c:pt idx="33">
                    <c:v>Jul-aug</c:v>
                  </c:pt>
                  <c:pt idx="34">
                    <c:v>Sep-Oct</c:v>
                  </c:pt>
                  <c:pt idx="35">
                    <c:v>Nov-Dec</c:v>
                  </c:pt>
                  <c:pt idx="36">
                    <c:v>Jan-Feb</c:v>
                  </c:pt>
                  <c:pt idx="37">
                    <c:v>Mar-Apr</c:v>
                  </c:pt>
                  <c:pt idx="38">
                    <c:v>May-Jun</c:v>
                  </c:pt>
                  <c:pt idx="39">
                    <c:v>Jul-aug</c:v>
                  </c:pt>
                  <c:pt idx="40">
                    <c:v>Sep-Oct</c:v>
                  </c:pt>
                  <c:pt idx="41">
                    <c:v>Nov-Dec</c:v>
                  </c:pt>
                  <c:pt idx="42">
                    <c:v>Jan-Feb</c:v>
                  </c:pt>
                  <c:pt idx="43">
                    <c:v>Mar-Apr</c:v>
                  </c:pt>
                  <c:pt idx="44">
                    <c:v>May-Jun</c:v>
                  </c:pt>
                  <c:pt idx="45">
                    <c:v>Jul-aug</c:v>
                  </c:pt>
                  <c:pt idx="46">
                    <c:v>Sep-Oct</c:v>
                  </c:pt>
                  <c:pt idx="47">
                    <c:v>Nov-Dec</c:v>
                  </c:pt>
                  <c:pt idx="48">
                    <c:v>Jan-Feb</c:v>
                  </c:pt>
                  <c:pt idx="49">
                    <c:v>Mar-Apr</c:v>
                  </c:pt>
                  <c:pt idx="50">
                    <c:v>May-Jun</c:v>
                  </c:pt>
                  <c:pt idx="51">
                    <c:v>Jul-aug</c:v>
                  </c:pt>
                  <c:pt idx="52">
                    <c:v>Sep-Oct</c:v>
                  </c:pt>
                  <c:pt idx="53">
                    <c:v>Nov-Dec</c:v>
                  </c:pt>
                  <c:pt idx="54">
                    <c:v>Jan-Feb</c:v>
                  </c:pt>
                  <c:pt idx="55">
                    <c:v>Mar-Apr</c:v>
                  </c:pt>
                  <c:pt idx="56">
                    <c:v>May-Jun</c:v>
                  </c:pt>
                  <c:pt idx="57">
                    <c:v>Jul-aug</c:v>
                  </c:pt>
                  <c:pt idx="58">
                    <c:v>Sep-Oct</c:v>
                  </c:pt>
                  <c:pt idx="59">
                    <c:v>Nov-Dec</c:v>
                  </c:pt>
                  <c:pt idx="60">
                    <c:v>Jan-Feb</c:v>
                  </c:pt>
                  <c:pt idx="61">
                    <c:v>Mar-Apr</c:v>
                  </c:pt>
                  <c:pt idx="62">
                    <c:v>May-Jun</c:v>
                  </c:pt>
                </c:lvl>
                <c:lvl>
                  <c:pt idx="0">
                    <c:v>1998</c:v>
                  </c:pt>
                  <c:pt idx="6">
                    <c:v>1999</c:v>
                  </c:pt>
                  <c:pt idx="12">
                    <c:v>2000</c:v>
                  </c:pt>
                  <c:pt idx="18">
                    <c:v>2001</c:v>
                  </c:pt>
                  <c:pt idx="24">
                    <c:v>2002</c:v>
                  </c:pt>
                  <c:pt idx="30">
                    <c:v>2003</c:v>
                  </c:pt>
                  <c:pt idx="36">
                    <c:v>2004</c:v>
                  </c:pt>
                  <c:pt idx="42">
                    <c:v>2005</c:v>
                  </c:pt>
                  <c:pt idx="48">
                    <c:v>2006</c:v>
                  </c:pt>
                  <c:pt idx="54">
                    <c:v>2007</c:v>
                  </c:pt>
                  <c:pt idx="60">
                    <c:v>2008</c:v>
                  </c:pt>
                </c:lvl>
              </c:multiLvlStrCache>
            </c:multiLvlStrRef>
          </c:cat>
          <c:val>
            <c:numRef>
              <c:f>'IP BIMESTRAL'!$B$3:$BL$3</c:f>
              <c:numCache>
                <c:formatCode>General</c:formatCode>
                <c:ptCount val="63"/>
                <c:pt idx="0">
                  <c:v>0.443824499112351</c:v>
                </c:pt>
                <c:pt idx="1">
                  <c:v>0.56105490452968443</c:v>
                </c:pt>
                <c:pt idx="2">
                  <c:v>1.9381888478823028</c:v>
                </c:pt>
                <c:pt idx="3">
                  <c:v>0.99594147175050729</c:v>
                </c:pt>
                <c:pt idx="4">
                  <c:v>0.27458546747260554</c:v>
                </c:pt>
                <c:pt idx="5">
                  <c:v>0.37136917219381999</c:v>
                </c:pt>
                <c:pt idx="6">
                  <c:v>0.65600798820346695</c:v>
                </c:pt>
                <c:pt idx="7">
                  <c:v>1.175405685500269</c:v>
                </c:pt>
                <c:pt idx="8">
                  <c:v>0.93173962425571466</c:v>
                </c:pt>
                <c:pt idx="9">
                  <c:v>0.41365231184027668</c:v>
                </c:pt>
                <c:pt idx="10">
                  <c:v>0.45681916813229484</c:v>
                </c:pt>
                <c:pt idx="11">
                  <c:v>0.69655075121675958</c:v>
                </c:pt>
                <c:pt idx="12">
                  <c:v>0.89885694933553328</c:v>
                </c:pt>
                <c:pt idx="13">
                  <c:v>0.993771857291327</c:v>
                </c:pt>
                <c:pt idx="14">
                  <c:v>0.86074081575083361</c:v>
                </c:pt>
                <c:pt idx="15">
                  <c:v>0.55104053209247172</c:v>
                </c:pt>
                <c:pt idx="16">
                  <c:v>0.3226908026855394</c:v>
                </c:pt>
                <c:pt idx="17">
                  <c:v>0.3455661681381767</c:v>
                </c:pt>
                <c:pt idx="18">
                  <c:v>0.41602900316479202</c:v>
                </c:pt>
                <c:pt idx="19">
                  <c:v>0.30086395820726108</c:v>
                </c:pt>
                <c:pt idx="20">
                  <c:v>0.48152787493289517</c:v>
                </c:pt>
                <c:pt idx="21">
                  <c:v>0.29649266616669867</c:v>
                </c:pt>
                <c:pt idx="22">
                  <c:v>0.1517623401752855</c:v>
                </c:pt>
                <c:pt idx="23">
                  <c:v>0.13263734383022421</c:v>
                </c:pt>
                <c:pt idx="24">
                  <c:v>0.28496015900776872</c:v>
                </c:pt>
                <c:pt idx="25">
                  <c:v>0.51360914044056249</c:v>
                </c:pt>
                <c:pt idx="26">
                  <c:v>0.6718190856217171</c:v>
                </c:pt>
                <c:pt idx="27">
                  <c:v>0.21038174362801332</c:v>
                </c:pt>
                <c:pt idx="28">
                  <c:v>0.14138614981276434</c:v>
                </c:pt>
                <c:pt idx="29">
                  <c:v>0.10601374491249257</c:v>
                </c:pt>
                <c:pt idx="30">
                  <c:v>0.41596532977344397</c:v>
                </c:pt>
                <c:pt idx="31">
                  <c:v>0.32910114250453448</c:v>
                </c:pt>
                <c:pt idx="32">
                  <c:v>0.43841622140019182</c:v>
                </c:pt>
                <c:pt idx="33">
                  <c:v>0.12051897966138322</c:v>
                </c:pt>
                <c:pt idx="34">
                  <c:v>9.0748219066200828E-2</c:v>
                </c:pt>
                <c:pt idx="35">
                  <c:v>9.4323605425493784E-2</c:v>
                </c:pt>
                <c:pt idx="36">
                  <c:v>0.22153755266645062</c:v>
                </c:pt>
                <c:pt idx="37">
                  <c:v>0.23162576015363104</c:v>
                </c:pt>
                <c:pt idx="38">
                  <c:v>0.2577984016499098</c:v>
                </c:pt>
                <c:pt idx="39">
                  <c:v>7.2814061204263675E-2</c:v>
                </c:pt>
                <c:pt idx="40">
                  <c:v>3.5505059470974612E-2</c:v>
                </c:pt>
                <c:pt idx="41">
                  <c:v>7.3905050486387625E-2</c:v>
                </c:pt>
                <c:pt idx="42">
                  <c:v>0.12110464739084362</c:v>
                </c:pt>
                <c:pt idx="43">
                  <c:v>0.2215368576517093</c:v>
                </c:pt>
                <c:pt idx="44">
                  <c:v>8.8662410870944869E-2</c:v>
                </c:pt>
                <c:pt idx="45">
                  <c:v>9.8705167664187077E-2</c:v>
                </c:pt>
                <c:pt idx="46">
                  <c:v>0.10786856215701168</c:v>
                </c:pt>
                <c:pt idx="47">
                  <c:v>0.10066041988524713</c:v>
                </c:pt>
                <c:pt idx="48">
                  <c:v>0.16183563831845735</c:v>
                </c:pt>
                <c:pt idx="49">
                  <c:v>0.49299712473488994</c:v>
                </c:pt>
                <c:pt idx="50">
                  <c:v>1.0412508409566108</c:v>
                </c:pt>
                <c:pt idx="51">
                  <c:v>0.19417401799345899</c:v>
                </c:pt>
                <c:pt idx="52">
                  <c:v>6.9579415625681304E-2</c:v>
                </c:pt>
                <c:pt idx="53">
                  <c:v>8.6937423357797833E-2</c:v>
                </c:pt>
                <c:pt idx="54">
                  <c:v>0.40410725706630857</c:v>
                </c:pt>
                <c:pt idx="55">
                  <c:v>0.72577975772925074</c:v>
                </c:pt>
                <c:pt idx="56">
                  <c:v>0.5007155195145726</c:v>
                </c:pt>
                <c:pt idx="57">
                  <c:v>0.14516376546512544</c:v>
                </c:pt>
                <c:pt idx="58">
                  <c:v>0.13678206513561941</c:v>
                </c:pt>
                <c:pt idx="59">
                  <c:v>0.1952683791575892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1938688"/>
        <c:axId val="61961344"/>
      </c:lineChart>
      <c:catAx>
        <c:axId val="61938688"/>
        <c:scaling>
          <c:orientation val="minMax"/>
        </c:scaling>
        <c:delete val="0"/>
        <c:axPos val="b"/>
        <c:majorTickMark val="out"/>
        <c:minorTickMark val="none"/>
        <c:tickLblPos val="nextTo"/>
        <c:crossAx val="61961344"/>
        <c:crosses val="autoZero"/>
        <c:auto val="1"/>
        <c:lblAlgn val="ctr"/>
        <c:lblOffset val="100"/>
        <c:noMultiLvlLbl val="0"/>
      </c:catAx>
      <c:valAx>
        <c:axId val="61961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19386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34755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94369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7736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0142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76143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12598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83722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04354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21637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996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59827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50DAB-B0C1-4043-A889-7A623EC68EB0}" type="datetimeFigureOut">
              <a:rPr lang="es-MX" smtClean="0"/>
              <a:pPr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7C6204-AF15-4F37-93B1-2714F964E3DA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68862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2 CuadroTexto"/>
          <p:cNvSpPr txBox="1">
            <a:spLocks noChangeArrowheads="1"/>
          </p:cNvSpPr>
          <p:nvPr/>
        </p:nvSpPr>
        <p:spPr bwMode="auto">
          <a:xfrm>
            <a:off x="3209061" y="543244"/>
            <a:ext cx="18133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MX" dirty="0" err="1" smtClean="0"/>
              <a:t>Additional</a:t>
            </a:r>
            <a:r>
              <a:rPr lang="es-MX" dirty="0" smtClean="0"/>
              <a:t> file 3</a:t>
            </a:r>
            <a:endParaRPr lang="es-MX" dirty="0"/>
          </a:p>
        </p:txBody>
      </p:sp>
      <p:sp>
        <p:nvSpPr>
          <p:cNvPr id="3" name="2 Rectángulo"/>
          <p:cNvSpPr/>
          <p:nvPr/>
        </p:nvSpPr>
        <p:spPr>
          <a:xfrm>
            <a:off x="971600" y="1031176"/>
            <a:ext cx="7416824" cy="43420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cxnSp>
        <p:nvCxnSpPr>
          <p:cNvPr id="4" name="3 Conector recto de flecha"/>
          <p:cNvCxnSpPr/>
          <p:nvPr/>
        </p:nvCxnSpPr>
        <p:spPr>
          <a:xfrm>
            <a:off x="5400441" y="1566947"/>
            <a:ext cx="224870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4 Conector recto de flecha"/>
          <p:cNvCxnSpPr/>
          <p:nvPr/>
        </p:nvCxnSpPr>
        <p:spPr>
          <a:xfrm>
            <a:off x="5364088" y="2167945"/>
            <a:ext cx="359610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5 Conector recto de flecha"/>
          <p:cNvCxnSpPr/>
          <p:nvPr/>
        </p:nvCxnSpPr>
        <p:spPr>
          <a:xfrm>
            <a:off x="5868144" y="2749601"/>
            <a:ext cx="264451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6 CuadroTexto"/>
          <p:cNvSpPr txBox="1"/>
          <p:nvPr/>
        </p:nvSpPr>
        <p:spPr>
          <a:xfrm>
            <a:off x="6064230" y="263570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4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5560174" y="14733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>
                <a:solidFill>
                  <a:schemeClr val="accent1">
                    <a:lumMod val="75000"/>
                  </a:schemeClr>
                </a:solidFill>
              </a:rPr>
              <a:t>1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5685108" y="206764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3</a:t>
            </a:r>
          </a:p>
        </p:txBody>
      </p:sp>
      <p:cxnSp>
        <p:nvCxnSpPr>
          <p:cNvPr id="10" name="9 Conector recto de flecha"/>
          <p:cNvCxnSpPr/>
          <p:nvPr/>
        </p:nvCxnSpPr>
        <p:spPr>
          <a:xfrm>
            <a:off x="4517175" y="3047400"/>
            <a:ext cx="210368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>
            <a:off x="5836322" y="3040678"/>
            <a:ext cx="207660" cy="0"/>
          </a:xfrm>
          <a:prstGeom prst="straightConnector1">
            <a:avLst/>
          </a:prstGeom>
          <a:ln>
            <a:solidFill>
              <a:schemeClr val="accent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 de flecha"/>
          <p:cNvCxnSpPr/>
          <p:nvPr/>
        </p:nvCxnSpPr>
        <p:spPr>
          <a:xfrm>
            <a:off x="4699701" y="3040678"/>
            <a:ext cx="1168443" cy="0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12 Conector recto de flecha"/>
          <p:cNvCxnSpPr/>
          <p:nvPr/>
        </p:nvCxnSpPr>
        <p:spPr>
          <a:xfrm>
            <a:off x="6719343" y="2507050"/>
            <a:ext cx="516953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13 Conector recto de flecha"/>
          <p:cNvCxnSpPr/>
          <p:nvPr/>
        </p:nvCxnSpPr>
        <p:spPr>
          <a:xfrm>
            <a:off x="4149198" y="1483579"/>
            <a:ext cx="422802" cy="1"/>
          </a:xfrm>
          <a:prstGeom prst="straightConnector1">
            <a:avLst/>
          </a:prstGeom>
          <a:ln w="19050"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14 CuadroTexto"/>
          <p:cNvSpPr txBox="1"/>
          <p:nvPr/>
        </p:nvSpPr>
        <p:spPr>
          <a:xfrm>
            <a:off x="6000369" y="2929612"/>
            <a:ext cx="235962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MX" sz="800" dirty="0">
                <a:solidFill>
                  <a:srgbClr val="0070C0"/>
                </a:solidFill>
              </a:rPr>
              <a:t>5</a:t>
            </a:r>
          </a:p>
        </p:txBody>
      </p:sp>
      <p:sp>
        <p:nvSpPr>
          <p:cNvPr id="16" name="15 CuadroTexto"/>
          <p:cNvSpPr txBox="1"/>
          <p:nvPr/>
        </p:nvSpPr>
        <p:spPr>
          <a:xfrm>
            <a:off x="7164288" y="239932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6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sp>
        <p:nvSpPr>
          <p:cNvPr id="17" name="16 CuadroTexto"/>
          <p:cNvSpPr txBox="1"/>
          <p:nvPr/>
        </p:nvSpPr>
        <p:spPr>
          <a:xfrm>
            <a:off x="4530440" y="137585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b="1" dirty="0">
                <a:solidFill>
                  <a:schemeClr val="accent6">
                    <a:lumMod val="50000"/>
                  </a:schemeClr>
                </a:solidFill>
              </a:rPr>
              <a:t>7</a:t>
            </a:r>
          </a:p>
        </p:txBody>
      </p:sp>
      <p:cxnSp>
        <p:nvCxnSpPr>
          <p:cNvPr id="18" name="17 Conector recto de flecha"/>
          <p:cNvCxnSpPr/>
          <p:nvPr/>
        </p:nvCxnSpPr>
        <p:spPr>
          <a:xfrm>
            <a:off x="7164288" y="2596034"/>
            <a:ext cx="264451" cy="0"/>
          </a:xfrm>
          <a:prstGeom prst="straightConnector1">
            <a:avLst/>
          </a:prstGeom>
          <a:ln>
            <a:solidFill>
              <a:schemeClr val="accent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18 Conector recto de flecha"/>
          <p:cNvCxnSpPr/>
          <p:nvPr/>
        </p:nvCxnSpPr>
        <p:spPr>
          <a:xfrm>
            <a:off x="4283968" y="2095937"/>
            <a:ext cx="192443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19 CuadroTexto"/>
          <p:cNvSpPr txBox="1"/>
          <p:nvPr/>
        </p:nvSpPr>
        <p:spPr>
          <a:xfrm>
            <a:off x="7379538" y="249169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70C0"/>
                </a:solidFill>
              </a:rPr>
              <a:t>8</a:t>
            </a:r>
            <a:endParaRPr lang="es-MX" sz="800" dirty="0">
              <a:solidFill>
                <a:srgbClr val="0070C0"/>
              </a:solidFill>
            </a:endParaRPr>
          </a:p>
        </p:txBody>
      </p:sp>
      <p:sp>
        <p:nvSpPr>
          <p:cNvPr id="21" name="20 CuadroTexto"/>
          <p:cNvSpPr txBox="1"/>
          <p:nvPr/>
        </p:nvSpPr>
        <p:spPr>
          <a:xfrm>
            <a:off x="4412459" y="198821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9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22" name="21 Conector recto de flecha"/>
          <p:cNvCxnSpPr/>
          <p:nvPr/>
        </p:nvCxnSpPr>
        <p:spPr>
          <a:xfrm>
            <a:off x="4979616" y="2606302"/>
            <a:ext cx="528488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22 CuadroTexto"/>
          <p:cNvSpPr txBox="1"/>
          <p:nvPr/>
        </p:nvSpPr>
        <p:spPr>
          <a:xfrm>
            <a:off x="5451389" y="249227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11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24" name="23 Conector recto de flecha"/>
          <p:cNvCxnSpPr/>
          <p:nvPr/>
        </p:nvCxnSpPr>
        <p:spPr>
          <a:xfrm>
            <a:off x="4201468" y="1699603"/>
            <a:ext cx="1209422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24 CuadroTexto"/>
          <p:cNvSpPr txBox="1"/>
          <p:nvPr/>
        </p:nvSpPr>
        <p:spPr>
          <a:xfrm>
            <a:off x="5359457" y="159772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12</a:t>
            </a:r>
            <a:endParaRPr lang="es-MX" sz="8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  <p:cxnSp>
        <p:nvCxnSpPr>
          <p:cNvPr id="26" name="25 Conector recto de flecha"/>
          <p:cNvCxnSpPr/>
          <p:nvPr/>
        </p:nvCxnSpPr>
        <p:spPr>
          <a:xfrm flipV="1">
            <a:off x="5257805" y="1771611"/>
            <a:ext cx="1417208" cy="5808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26 CuadroTexto"/>
          <p:cNvSpPr txBox="1"/>
          <p:nvPr/>
        </p:nvSpPr>
        <p:spPr>
          <a:xfrm>
            <a:off x="6617218" y="165983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13</a:t>
            </a:r>
            <a:endParaRPr lang="es-MX" sz="8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  <p:cxnSp>
        <p:nvCxnSpPr>
          <p:cNvPr id="28" name="27 Conector recto de flecha"/>
          <p:cNvCxnSpPr/>
          <p:nvPr/>
        </p:nvCxnSpPr>
        <p:spPr>
          <a:xfrm>
            <a:off x="4751029" y="2059643"/>
            <a:ext cx="697699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28 CuadroTexto"/>
          <p:cNvSpPr txBox="1"/>
          <p:nvPr/>
        </p:nvSpPr>
        <p:spPr>
          <a:xfrm>
            <a:off x="5364862" y="194060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70C0"/>
                </a:solidFill>
              </a:rPr>
              <a:t>14</a:t>
            </a:r>
            <a:endParaRPr lang="es-MX" sz="800" dirty="0">
              <a:solidFill>
                <a:srgbClr val="0070C0"/>
              </a:solidFill>
            </a:endParaRPr>
          </a:p>
        </p:txBody>
      </p:sp>
      <p:cxnSp>
        <p:nvCxnSpPr>
          <p:cNvPr id="30" name="29 Conector recto de flecha"/>
          <p:cNvCxnSpPr/>
          <p:nvPr/>
        </p:nvCxnSpPr>
        <p:spPr>
          <a:xfrm>
            <a:off x="6660232" y="1699603"/>
            <a:ext cx="697679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30 CuadroTexto"/>
          <p:cNvSpPr txBox="1"/>
          <p:nvPr/>
        </p:nvSpPr>
        <p:spPr>
          <a:xfrm>
            <a:off x="7270311" y="1597723"/>
            <a:ext cx="28725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15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32" name="31 Conector recto de flecha"/>
          <p:cNvCxnSpPr/>
          <p:nvPr/>
        </p:nvCxnSpPr>
        <p:spPr>
          <a:xfrm flipV="1">
            <a:off x="6804248" y="1483579"/>
            <a:ext cx="449137" cy="1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32 CuadroTexto"/>
          <p:cNvSpPr txBox="1"/>
          <p:nvPr/>
        </p:nvSpPr>
        <p:spPr>
          <a:xfrm>
            <a:off x="7190769" y="136954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16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34" name="33 Conector recto de flecha"/>
          <p:cNvCxnSpPr/>
          <p:nvPr/>
        </p:nvCxnSpPr>
        <p:spPr>
          <a:xfrm>
            <a:off x="6012160" y="1483579"/>
            <a:ext cx="503282" cy="1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34 CuadroTexto"/>
          <p:cNvSpPr txBox="1"/>
          <p:nvPr/>
        </p:nvSpPr>
        <p:spPr>
          <a:xfrm>
            <a:off x="6440955" y="137527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17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36" name="35 Conector recto de flecha"/>
          <p:cNvCxnSpPr/>
          <p:nvPr/>
        </p:nvCxnSpPr>
        <p:spPr>
          <a:xfrm>
            <a:off x="5430064" y="2270334"/>
            <a:ext cx="510088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36 CuadroTexto"/>
          <p:cNvSpPr txBox="1"/>
          <p:nvPr/>
        </p:nvSpPr>
        <p:spPr>
          <a:xfrm>
            <a:off x="5868531" y="216794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18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38" name="37 Conector recto de flecha"/>
          <p:cNvCxnSpPr/>
          <p:nvPr/>
        </p:nvCxnSpPr>
        <p:spPr>
          <a:xfrm>
            <a:off x="6819589" y="1833167"/>
            <a:ext cx="528488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38 Conector recto de flecha"/>
          <p:cNvCxnSpPr/>
          <p:nvPr/>
        </p:nvCxnSpPr>
        <p:spPr>
          <a:xfrm>
            <a:off x="7341037" y="1844209"/>
            <a:ext cx="211272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39 CuadroTexto"/>
          <p:cNvSpPr txBox="1"/>
          <p:nvPr/>
        </p:nvSpPr>
        <p:spPr>
          <a:xfrm>
            <a:off x="7463133" y="172544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19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41" name="40 Conector recto de flecha"/>
          <p:cNvCxnSpPr/>
          <p:nvPr/>
        </p:nvCxnSpPr>
        <p:spPr>
          <a:xfrm flipV="1">
            <a:off x="1573444" y="1627595"/>
            <a:ext cx="1990057" cy="580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41 Conector recto de flecha"/>
          <p:cNvCxnSpPr/>
          <p:nvPr/>
        </p:nvCxnSpPr>
        <p:spPr>
          <a:xfrm>
            <a:off x="2267744" y="1566367"/>
            <a:ext cx="2663522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42 CuadroTexto"/>
          <p:cNvSpPr txBox="1"/>
          <p:nvPr/>
        </p:nvSpPr>
        <p:spPr>
          <a:xfrm>
            <a:off x="4860032" y="1458645"/>
            <a:ext cx="28725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20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44" name="43 Conector recto de flecha"/>
          <p:cNvCxnSpPr/>
          <p:nvPr/>
        </p:nvCxnSpPr>
        <p:spPr>
          <a:xfrm>
            <a:off x="7264277" y="2101200"/>
            <a:ext cx="475301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44 CuadroTexto"/>
          <p:cNvSpPr txBox="1"/>
          <p:nvPr/>
        </p:nvSpPr>
        <p:spPr>
          <a:xfrm>
            <a:off x="7675954" y="198581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21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sp>
        <p:nvSpPr>
          <p:cNvPr id="46" name="45 CuadroTexto"/>
          <p:cNvSpPr txBox="1"/>
          <p:nvPr/>
        </p:nvSpPr>
        <p:spPr>
          <a:xfrm>
            <a:off x="3563114" y="1985819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31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47" name="46 Conector recto de flecha"/>
          <p:cNvCxnSpPr/>
          <p:nvPr/>
        </p:nvCxnSpPr>
        <p:spPr>
          <a:xfrm>
            <a:off x="6894303" y="2317224"/>
            <a:ext cx="845275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47 CuadroTexto"/>
          <p:cNvSpPr txBox="1"/>
          <p:nvPr/>
        </p:nvSpPr>
        <p:spPr>
          <a:xfrm>
            <a:off x="7667570" y="221501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22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49" name="48 Conector recto de flecha"/>
          <p:cNvCxnSpPr/>
          <p:nvPr/>
        </p:nvCxnSpPr>
        <p:spPr>
          <a:xfrm>
            <a:off x="7380312" y="2203659"/>
            <a:ext cx="165643" cy="0"/>
          </a:xfrm>
          <a:prstGeom prst="straightConnector1">
            <a:avLst/>
          </a:prstGeom>
          <a:ln w="19050"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49 CuadroTexto"/>
          <p:cNvSpPr txBox="1"/>
          <p:nvPr/>
        </p:nvSpPr>
        <p:spPr>
          <a:xfrm>
            <a:off x="7463133" y="2101200"/>
            <a:ext cx="287258" cy="215444"/>
          </a:xfrm>
          <a:prstGeom prst="rect">
            <a:avLst/>
          </a:prstGeom>
          <a:noFill/>
          <a:ln>
            <a:noFill/>
            <a:headEnd type="diamond" w="med" len="med"/>
            <a:tailEnd type="triangle" w="med" len="med"/>
          </a:ln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23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51" name="50 Conector recto de flecha"/>
          <p:cNvCxnSpPr/>
          <p:nvPr/>
        </p:nvCxnSpPr>
        <p:spPr>
          <a:xfrm>
            <a:off x="7524328" y="2419683"/>
            <a:ext cx="165643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51 CuadroTexto"/>
          <p:cNvSpPr txBox="1"/>
          <p:nvPr/>
        </p:nvSpPr>
        <p:spPr>
          <a:xfrm>
            <a:off x="7635215" y="231722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24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sp>
        <p:nvSpPr>
          <p:cNvPr id="53" name="52 CuadroTexto"/>
          <p:cNvSpPr txBox="1"/>
          <p:nvPr/>
        </p:nvSpPr>
        <p:spPr>
          <a:xfrm>
            <a:off x="7740352" y="242026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70C0"/>
                </a:solidFill>
              </a:rPr>
              <a:t>25</a:t>
            </a:r>
            <a:endParaRPr lang="es-MX" sz="800" dirty="0">
              <a:solidFill>
                <a:srgbClr val="0070C0"/>
              </a:solidFill>
            </a:endParaRPr>
          </a:p>
        </p:txBody>
      </p:sp>
      <p:cxnSp>
        <p:nvCxnSpPr>
          <p:cNvPr id="54" name="53 Conector recto de flecha"/>
          <p:cNvCxnSpPr/>
          <p:nvPr/>
        </p:nvCxnSpPr>
        <p:spPr>
          <a:xfrm>
            <a:off x="7357911" y="2528290"/>
            <a:ext cx="461672" cy="0"/>
          </a:xfrm>
          <a:prstGeom prst="straightConnector1">
            <a:avLst/>
          </a:prstGeom>
          <a:ln>
            <a:solidFill>
              <a:schemeClr val="accent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54 Conector recto de flecha"/>
          <p:cNvCxnSpPr/>
          <p:nvPr/>
        </p:nvCxnSpPr>
        <p:spPr>
          <a:xfrm>
            <a:off x="6803474" y="1985819"/>
            <a:ext cx="709266" cy="1816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55 CuadroTexto"/>
          <p:cNvSpPr txBox="1"/>
          <p:nvPr/>
        </p:nvSpPr>
        <p:spPr>
          <a:xfrm>
            <a:off x="7445118" y="188049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27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57" name="56 Conector recto de flecha"/>
          <p:cNvCxnSpPr/>
          <p:nvPr/>
        </p:nvCxnSpPr>
        <p:spPr>
          <a:xfrm>
            <a:off x="2375562" y="1365077"/>
            <a:ext cx="4428686" cy="0"/>
          </a:xfrm>
          <a:prstGeom prst="straightConnector1">
            <a:avLst/>
          </a:prstGeom>
          <a:ln w="6350">
            <a:solidFill>
              <a:srgbClr val="0070C0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57 CuadroTexto"/>
          <p:cNvSpPr txBox="1"/>
          <p:nvPr/>
        </p:nvSpPr>
        <p:spPr>
          <a:xfrm>
            <a:off x="6732240" y="231722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28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59" name="58 Conector recto de flecha"/>
          <p:cNvCxnSpPr/>
          <p:nvPr/>
        </p:nvCxnSpPr>
        <p:spPr>
          <a:xfrm>
            <a:off x="4223751" y="2419683"/>
            <a:ext cx="2595838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59 CuadroTexto"/>
          <p:cNvSpPr txBox="1"/>
          <p:nvPr/>
        </p:nvSpPr>
        <p:spPr>
          <a:xfrm>
            <a:off x="6732240" y="1268135"/>
            <a:ext cx="28725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29</a:t>
            </a:r>
            <a:endParaRPr lang="es-MX" sz="8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61" name="60 CuadroTexto"/>
          <p:cNvSpPr txBox="1"/>
          <p:nvPr/>
        </p:nvSpPr>
        <p:spPr>
          <a:xfrm>
            <a:off x="4788024" y="210178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30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62" name="61 Conector recto de flecha"/>
          <p:cNvCxnSpPr/>
          <p:nvPr/>
        </p:nvCxnSpPr>
        <p:spPr>
          <a:xfrm>
            <a:off x="4283968" y="2203659"/>
            <a:ext cx="576064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62 Conector recto de flecha"/>
          <p:cNvCxnSpPr/>
          <p:nvPr/>
        </p:nvCxnSpPr>
        <p:spPr>
          <a:xfrm>
            <a:off x="3203074" y="2079640"/>
            <a:ext cx="416996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63 CuadroTexto"/>
          <p:cNvSpPr txBox="1"/>
          <p:nvPr/>
        </p:nvSpPr>
        <p:spPr>
          <a:xfrm>
            <a:off x="7740352" y="1484159"/>
            <a:ext cx="28725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34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65" name="64 Conector recto de flecha"/>
          <p:cNvCxnSpPr/>
          <p:nvPr/>
        </p:nvCxnSpPr>
        <p:spPr>
          <a:xfrm>
            <a:off x="6819589" y="2832934"/>
            <a:ext cx="658680" cy="0"/>
          </a:xfrm>
          <a:prstGeom prst="straightConnector1">
            <a:avLst/>
          </a:prstGeom>
          <a:ln>
            <a:solidFill>
              <a:schemeClr val="accent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65 CuadroTexto"/>
          <p:cNvSpPr txBox="1"/>
          <p:nvPr/>
        </p:nvSpPr>
        <p:spPr>
          <a:xfrm>
            <a:off x="7408680" y="270829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70C0"/>
                </a:solidFill>
              </a:rPr>
              <a:t>33</a:t>
            </a:r>
            <a:endParaRPr lang="es-MX" sz="800" dirty="0">
              <a:solidFill>
                <a:srgbClr val="0070C0"/>
              </a:solidFill>
            </a:endParaRPr>
          </a:p>
        </p:txBody>
      </p:sp>
      <p:cxnSp>
        <p:nvCxnSpPr>
          <p:cNvPr id="67" name="66 Conector recto de flecha"/>
          <p:cNvCxnSpPr/>
          <p:nvPr/>
        </p:nvCxnSpPr>
        <p:spPr>
          <a:xfrm>
            <a:off x="7741126" y="2203659"/>
            <a:ext cx="287258" cy="0"/>
          </a:xfrm>
          <a:prstGeom prst="straightConnector1">
            <a:avLst/>
          </a:prstGeom>
          <a:ln w="19050"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67 Conector recto de flecha"/>
          <p:cNvCxnSpPr/>
          <p:nvPr/>
        </p:nvCxnSpPr>
        <p:spPr>
          <a:xfrm>
            <a:off x="6516216" y="1591301"/>
            <a:ext cx="144016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68 CuadroTexto"/>
          <p:cNvSpPr txBox="1"/>
          <p:nvPr/>
        </p:nvSpPr>
        <p:spPr>
          <a:xfrm>
            <a:off x="6617218" y="1483579"/>
            <a:ext cx="28725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36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70" name="69 Conector recto de flecha"/>
          <p:cNvCxnSpPr/>
          <p:nvPr/>
        </p:nvCxnSpPr>
        <p:spPr>
          <a:xfrm>
            <a:off x="2339752" y="2275667"/>
            <a:ext cx="1728192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70 CuadroTexto"/>
          <p:cNvSpPr txBox="1"/>
          <p:nvPr/>
        </p:nvSpPr>
        <p:spPr>
          <a:xfrm>
            <a:off x="3995936" y="216822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37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72" name="71 CuadroTexto"/>
          <p:cNvSpPr txBox="1"/>
          <p:nvPr/>
        </p:nvSpPr>
        <p:spPr>
          <a:xfrm>
            <a:off x="7956376" y="209720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38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73" name="72 Conector recto de flecha"/>
          <p:cNvCxnSpPr/>
          <p:nvPr/>
        </p:nvCxnSpPr>
        <p:spPr>
          <a:xfrm>
            <a:off x="7445118" y="2707715"/>
            <a:ext cx="581718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73 CuadroTexto"/>
          <p:cNvSpPr txBox="1"/>
          <p:nvPr/>
        </p:nvSpPr>
        <p:spPr>
          <a:xfrm>
            <a:off x="7977539" y="259585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39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75" name="74 Conector recto de flecha"/>
          <p:cNvCxnSpPr/>
          <p:nvPr/>
        </p:nvCxnSpPr>
        <p:spPr>
          <a:xfrm>
            <a:off x="4860419" y="2923739"/>
            <a:ext cx="2980791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75 CuadroTexto"/>
          <p:cNvSpPr txBox="1"/>
          <p:nvPr/>
        </p:nvSpPr>
        <p:spPr>
          <a:xfrm>
            <a:off x="7778844" y="281601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40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77" name="76 Conector recto de flecha"/>
          <p:cNvCxnSpPr/>
          <p:nvPr/>
        </p:nvCxnSpPr>
        <p:spPr>
          <a:xfrm>
            <a:off x="7481462" y="3067755"/>
            <a:ext cx="359748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77 CuadroTexto"/>
          <p:cNvSpPr txBox="1"/>
          <p:nvPr/>
        </p:nvSpPr>
        <p:spPr>
          <a:xfrm>
            <a:off x="7778844" y="296117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41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79" name="78 Conector recto de flecha"/>
          <p:cNvCxnSpPr/>
          <p:nvPr/>
        </p:nvCxnSpPr>
        <p:spPr>
          <a:xfrm>
            <a:off x="2893658" y="1286705"/>
            <a:ext cx="4931599" cy="6364"/>
          </a:xfrm>
          <a:prstGeom prst="straightConnector1">
            <a:avLst/>
          </a:prstGeom>
          <a:ln>
            <a:solidFill>
              <a:schemeClr val="accent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79 CuadroTexto"/>
          <p:cNvSpPr txBox="1"/>
          <p:nvPr/>
        </p:nvSpPr>
        <p:spPr>
          <a:xfrm>
            <a:off x="7752243" y="1175192"/>
            <a:ext cx="28725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70C0"/>
                </a:solidFill>
              </a:rPr>
              <a:t>42</a:t>
            </a:r>
            <a:endParaRPr lang="es-MX" sz="800" dirty="0">
              <a:solidFill>
                <a:srgbClr val="0070C0"/>
              </a:solidFill>
            </a:endParaRPr>
          </a:p>
        </p:txBody>
      </p:sp>
      <p:cxnSp>
        <p:nvCxnSpPr>
          <p:cNvPr id="81" name="80 Conector recto de flecha"/>
          <p:cNvCxnSpPr/>
          <p:nvPr/>
        </p:nvCxnSpPr>
        <p:spPr>
          <a:xfrm>
            <a:off x="2555776" y="2203659"/>
            <a:ext cx="271717" cy="0"/>
          </a:xfrm>
          <a:prstGeom prst="straightConnector1">
            <a:avLst/>
          </a:prstGeom>
          <a:ln w="19050"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81 CuadroTexto"/>
          <p:cNvSpPr txBox="1"/>
          <p:nvPr/>
        </p:nvSpPr>
        <p:spPr>
          <a:xfrm>
            <a:off x="2952801" y="209302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43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83" name="82 Conector recto de flecha"/>
          <p:cNvCxnSpPr/>
          <p:nvPr/>
        </p:nvCxnSpPr>
        <p:spPr>
          <a:xfrm>
            <a:off x="2820876" y="2203659"/>
            <a:ext cx="191505" cy="0"/>
          </a:xfrm>
          <a:prstGeom prst="straightConnector1">
            <a:avLst/>
          </a:prstGeom>
          <a:ln w="19050">
            <a:solidFill>
              <a:schemeClr val="accent6">
                <a:lumMod val="50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83 Conector recto de flecha"/>
          <p:cNvCxnSpPr/>
          <p:nvPr/>
        </p:nvCxnSpPr>
        <p:spPr>
          <a:xfrm>
            <a:off x="2411760" y="1447285"/>
            <a:ext cx="493627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84 CuadroTexto"/>
          <p:cNvSpPr txBox="1"/>
          <p:nvPr/>
        </p:nvSpPr>
        <p:spPr>
          <a:xfrm>
            <a:off x="2843808" y="133956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45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86" name="85 Conector recto de flecha"/>
          <p:cNvCxnSpPr/>
          <p:nvPr/>
        </p:nvCxnSpPr>
        <p:spPr>
          <a:xfrm>
            <a:off x="2627784" y="1771611"/>
            <a:ext cx="432435" cy="0"/>
          </a:xfrm>
          <a:prstGeom prst="straightConnector1">
            <a:avLst/>
          </a:prstGeom>
          <a:ln w="19050"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86 CuadroTexto"/>
          <p:cNvSpPr txBox="1"/>
          <p:nvPr/>
        </p:nvSpPr>
        <p:spPr>
          <a:xfrm>
            <a:off x="3021688" y="166679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46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sp>
        <p:nvSpPr>
          <p:cNvPr id="88" name="87 CuadroTexto"/>
          <p:cNvSpPr txBox="1"/>
          <p:nvPr/>
        </p:nvSpPr>
        <p:spPr>
          <a:xfrm>
            <a:off x="4894011" y="262298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48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89" name="88 Conector recto de flecha"/>
          <p:cNvCxnSpPr/>
          <p:nvPr/>
        </p:nvCxnSpPr>
        <p:spPr>
          <a:xfrm>
            <a:off x="2339752" y="2707715"/>
            <a:ext cx="2630795" cy="0"/>
          </a:xfrm>
          <a:prstGeom prst="straightConnector1">
            <a:avLst/>
          </a:prstGeom>
          <a:ln>
            <a:solidFill>
              <a:schemeClr val="tx2">
                <a:lumMod val="60000"/>
                <a:lumOff val="4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89 CuadroTexto"/>
          <p:cNvSpPr txBox="1"/>
          <p:nvPr/>
        </p:nvSpPr>
        <p:spPr>
          <a:xfrm>
            <a:off x="3815529" y="173199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49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91" name="90 Conector recto de flecha"/>
          <p:cNvCxnSpPr/>
          <p:nvPr/>
        </p:nvCxnSpPr>
        <p:spPr>
          <a:xfrm>
            <a:off x="3491880" y="1843619"/>
            <a:ext cx="382972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91 Conector recto de flecha"/>
          <p:cNvCxnSpPr/>
          <p:nvPr/>
        </p:nvCxnSpPr>
        <p:spPr>
          <a:xfrm>
            <a:off x="3563888" y="2491691"/>
            <a:ext cx="1169181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92 CuadroTexto"/>
          <p:cNvSpPr txBox="1"/>
          <p:nvPr/>
        </p:nvSpPr>
        <p:spPr>
          <a:xfrm>
            <a:off x="4683289" y="239289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53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94" name="93 Conector recto de flecha"/>
          <p:cNvCxnSpPr/>
          <p:nvPr/>
        </p:nvCxnSpPr>
        <p:spPr>
          <a:xfrm>
            <a:off x="3203848" y="1447285"/>
            <a:ext cx="360039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94 CuadroTexto"/>
          <p:cNvSpPr txBox="1"/>
          <p:nvPr/>
        </p:nvSpPr>
        <p:spPr>
          <a:xfrm>
            <a:off x="3511520" y="133956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54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96" name="95 Conector recto de flecha"/>
          <p:cNvCxnSpPr/>
          <p:nvPr/>
        </p:nvCxnSpPr>
        <p:spPr>
          <a:xfrm>
            <a:off x="3156378" y="2347675"/>
            <a:ext cx="551526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96 CuadroTexto"/>
          <p:cNvSpPr txBox="1"/>
          <p:nvPr/>
        </p:nvSpPr>
        <p:spPr>
          <a:xfrm>
            <a:off x="3642668" y="223995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55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98" name="97 Conector recto de flecha"/>
          <p:cNvCxnSpPr/>
          <p:nvPr/>
        </p:nvCxnSpPr>
        <p:spPr>
          <a:xfrm>
            <a:off x="2267744" y="1915627"/>
            <a:ext cx="423890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98 CuadroTexto"/>
          <p:cNvSpPr txBox="1"/>
          <p:nvPr/>
        </p:nvSpPr>
        <p:spPr>
          <a:xfrm>
            <a:off x="2643468" y="180790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56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100" name="99 Conector recto de flecha"/>
          <p:cNvCxnSpPr/>
          <p:nvPr/>
        </p:nvCxnSpPr>
        <p:spPr>
          <a:xfrm>
            <a:off x="3371652" y="1699603"/>
            <a:ext cx="408260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100 CuadroTexto"/>
          <p:cNvSpPr txBox="1"/>
          <p:nvPr/>
        </p:nvSpPr>
        <p:spPr>
          <a:xfrm>
            <a:off x="3718311" y="159772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57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2" name="101 CuadroTexto"/>
          <p:cNvSpPr txBox="1"/>
          <p:nvPr/>
        </p:nvSpPr>
        <p:spPr>
          <a:xfrm>
            <a:off x="4243668" y="253375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63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103" name="102 Conector recto de flecha"/>
          <p:cNvCxnSpPr/>
          <p:nvPr/>
        </p:nvCxnSpPr>
        <p:spPr>
          <a:xfrm>
            <a:off x="3203848" y="1915627"/>
            <a:ext cx="307672" cy="581"/>
          </a:xfrm>
          <a:prstGeom prst="straightConnector1">
            <a:avLst/>
          </a:prstGeom>
          <a:ln w="19050"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103 CuadroTexto"/>
          <p:cNvSpPr txBox="1"/>
          <p:nvPr/>
        </p:nvSpPr>
        <p:spPr>
          <a:xfrm>
            <a:off x="3442888" y="179738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58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105" name="104 Conector recto de flecha"/>
          <p:cNvCxnSpPr/>
          <p:nvPr/>
        </p:nvCxnSpPr>
        <p:spPr>
          <a:xfrm>
            <a:off x="3059832" y="2491691"/>
            <a:ext cx="131301" cy="0"/>
          </a:xfrm>
          <a:prstGeom prst="straightConnector1">
            <a:avLst/>
          </a:prstGeom>
          <a:ln w="19050"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105 CuadroTexto"/>
          <p:cNvSpPr txBox="1"/>
          <p:nvPr/>
        </p:nvSpPr>
        <p:spPr>
          <a:xfrm>
            <a:off x="3145418" y="238366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70C0"/>
                </a:solidFill>
              </a:rPr>
              <a:t>59</a:t>
            </a:r>
            <a:endParaRPr lang="es-MX" sz="800" dirty="0">
              <a:solidFill>
                <a:srgbClr val="0070C0"/>
              </a:solidFill>
            </a:endParaRPr>
          </a:p>
        </p:txBody>
      </p:sp>
      <p:cxnSp>
        <p:nvCxnSpPr>
          <p:cNvPr id="107" name="106 Conector recto de flecha"/>
          <p:cNvCxnSpPr/>
          <p:nvPr/>
        </p:nvCxnSpPr>
        <p:spPr>
          <a:xfrm flipV="1">
            <a:off x="3779912" y="1987055"/>
            <a:ext cx="421556" cy="58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107 CuadroTexto"/>
          <p:cNvSpPr txBox="1"/>
          <p:nvPr/>
        </p:nvSpPr>
        <p:spPr>
          <a:xfrm>
            <a:off x="4139196" y="186419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60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109" name="108 Conector recto de flecha"/>
          <p:cNvCxnSpPr/>
          <p:nvPr/>
        </p:nvCxnSpPr>
        <p:spPr>
          <a:xfrm>
            <a:off x="4283968" y="1771611"/>
            <a:ext cx="466414" cy="0"/>
          </a:xfrm>
          <a:prstGeom prst="straightConnector1">
            <a:avLst/>
          </a:prstGeom>
          <a:ln>
            <a:noFill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109 CuadroTexto"/>
          <p:cNvSpPr txBox="1"/>
          <p:nvPr/>
        </p:nvSpPr>
        <p:spPr>
          <a:xfrm>
            <a:off x="4733751" y="1725163"/>
            <a:ext cx="287258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61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111" name="110 Conector recto de flecha"/>
          <p:cNvCxnSpPr/>
          <p:nvPr/>
        </p:nvCxnSpPr>
        <p:spPr>
          <a:xfrm>
            <a:off x="2411760" y="2059643"/>
            <a:ext cx="518966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111 CuadroTexto"/>
          <p:cNvSpPr txBox="1"/>
          <p:nvPr/>
        </p:nvSpPr>
        <p:spPr>
          <a:xfrm>
            <a:off x="2865661" y="195992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62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113" name="112 Conector recto de flecha"/>
          <p:cNvCxnSpPr/>
          <p:nvPr/>
        </p:nvCxnSpPr>
        <p:spPr>
          <a:xfrm>
            <a:off x="2411760" y="2635707"/>
            <a:ext cx="144016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113 Conector recto de flecha"/>
          <p:cNvCxnSpPr/>
          <p:nvPr/>
        </p:nvCxnSpPr>
        <p:spPr>
          <a:xfrm>
            <a:off x="2555776" y="2635620"/>
            <a:ext cx="1728192" cy="87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114 Conector recto de flecha"/>
          <p:cNvCxnSpPr/>
          <p:nvPr/>
        </p:nvCxnSpPr>
        <p:spPr>
          <a:xfrm>
            <a:off x="2348224" y="2419683"/>
            <a:ext cx="495584" cy="1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115 CuadroTexto"/>
          <p:cNvSpPr txBox="1"/>
          <p:nvPr/>
        </p:nvSpPr>
        <p:spPr>
          <a:xfrm>
            <a:off x="2761758" y="231722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6">
                    <a:lumMod val="50000"/>
                  </a:schemeClr>
                </a:solidFill>
              </a:rPr>
              <a:t>64</a:t>
            </a:r>
            <a:endParaRPr lang="es-MX" sz="800" dirty="0">
              <a:solidFill>
                <a:schemeClr val="accent6">
                  <a:lumMod val="50000"/>
                </a:schemeClr>
              </a:solidFill>
            </a:endParaRPr>
          </a:p>
        </p:txBody>
      </p:sp>
      <p:cxnSp>
        <p:nvCxnSpPr>
          <p:cNvPr id="117" name="116 Conector recto de flecha"/>
          <p:cNvCxnSpPr/>
          <p:nvPr/>
        </p:nvCxnSpPr>
        <p:spPr>
          <a:xfrm>
            <a:off x="2267744" y="2851731"/>
            <a:ext cx="2538435" cy="0"/>
          </a:xfrm>
          <a:prstGeom prst="straightConnector1">
            <a:avLst/>
          </a:prstGeom>
          <a:ln>
            <a:solidFill>
              <a:schemeClr val="tx2">
                <a:lumMod val="60000"/>
                <a:lumOff val="4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117 CuadroTexto"/>
          <p:cNvSpPr txBox="1"/>
          <p:nvPr/>
        </p:nvSpPr>
        <p:spPr>
          <a:xfrm>
            <a:off x="4744418" y="273071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65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119" name="118 Conector recto de flecha"/>
          <p:cNvCxnSpPr/>
          <p:nvPr/>
        </p:nvCxnSpPr>
        <p:spPr>
          <a:xfrm>
            <a:off x="2365632" y="2923739"/>
            <a:ext cx="759850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119 CuadroTexto"/>
          <p:cNvSpPr txBox="1"/>
          <p:nvPr/>
        </p:nvSpPr>
        <p:spPr>
          <a:xfrm>
            <a:off x="3047504" y="281601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67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121" name="120 Conector recto de flecha"/>
          <p:cNvCxnSpPr/>
          <p:nvPr/>
        </p:nvCxnSpPr>
        <p:spPr>
          <a:xfrm>
            <a:off x="2735797" y="3067755"/>
            <a:ext cx="540059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121 CuadroTexto"/>
          <p:cNvSpPr txBox="1"/>
          <p:nvPr/>
        </p:nvSpPr>
        <p:spPr>
          <a:xfrm>
            <a:off x="3214055" y="296003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/>
              <a:t>68</a:t>
            </a:r>
            <a:endParaRPr lang="es-MX" sz="800" dirty="0"/>
          </a:p>
        </p:txBody>
      </p:sp>
      <p:cxnSp>
        <p:nvCxnSpPr>
          <p:cNvPr id="123" name="122 Conector recto de flecha"/>
          <p:cNvCxnSpPr/>
          <p:nvPr/>
        </p:nvCxnSpPr>
        <p:spPr>
          <a:xfrm>
            <a:off x="1979712" y="1191316"/>
            <a:ext cx="2350454" cy="0"/>
          </a:xfrm>
          <a:prstGeom prst="straightConnector1">
            <a:avLst/>
          </a:prstGeom>
          <a:ln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123 CuadroTexto"/>
          <p:cNvSpPr txBox="1"/>
          <p:nvPr/>
        </p:nvSpPr>
        <p:spPr>
          <a:xfrm>
            <a:off x="4268830" y="105702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69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25" name="124 CuadroTexto"/>
          <p:cNvSpPr txBox="1"/>
          <p:nvPr/>
        </p:nvSpPr>
        <p:spPr>
          <a:xfrm rot="5400000" flipV="1">
            <a:off x="-188565" y="2716958"/>
            <a:ext cx="2597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dirty="0" smtClean="0">
                <a:latin typeface="Times New Roman" pitchFamily="18" charset="0"/>
                <a:cs typeface="Times New Roman" pitchFamily="18" charset="0"/>
              </a:rPr>
              <a:t>No. of </a:t>
            </a:r>
            <a:r>
              <a:rPr lang="es-MX" sz="1200" i="1" dirty="0" smtClean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s-MX" sz="1200" i="1" dirty="0" err="1" smtClean="0">
                <a:latin typeface="Times New Roman" pitchFamily="18" charset="0"/>
                <a:cs typeface="Times New Roman" pitchFamily="18" charset="0"/>
              </a:rPr>
              <a:t>vivax</a:t>
            </a:r>
            <a:r>
              <a:rPr lang="es-MX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MX" sz="1200" dirty="0" smtClean="0">
                <a:latin typeface="Times New Roman" pitchFamily="18" charset="0"/>
                <a:cs typeface="Times New Roman" pitchFamily="18" charset="0"/>
              </a:rPr>
              <a:t>cases </a:t>
            </a:r>
            <a:r>
              <a:rPr lang="es-MX" sz="1200" dirty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s-MX" sz="1200" dirty="0" smtClean="0">
                <a:latin typeface="Times New Roman" pitchFamily="18" charset="0"/>
                <a:cs typeface="Times New Roman" pitchFamily="18" charset="0"/>
              </a:rPr>
              <a:t>1,000 </a:t>
            </a:r>
            <a:r>
              <a:rPr lang="es-MX" sz="1200" dirty="0" err="1" smtClean="0">
                <a:latin typeface="Times New Roman" pitchFamily="18" charset="0"/>
                <a:cs typeface="Times New Roman" pitchFamily="18" charset="0"/>
              </a:rPr>
              <a:t>people</a:t>
            </a:r>
            <a:r>
              <a:rPr lang="es-MX" sz="1200" dirty="0" smtClean="0">
                <a:latin typeface="Times New Roman" pitchFamily="18" charset="0"/>
                <a:cs typeface="Times New Roman" pitchFamily="18" charset="0"/>
              </a:rPr>
              <a:t> 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125 CuadroTexto"/>
          <p:cNvSpPr txBox="1"/>
          <p:nvPr/>
        </p:nvSpPr>
        <p:spPr>
          <a:xfrm>
            <a:off x="3489741" y="152045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chemeClr val="accent1">
                    <a:lumMod val="75000"/>
                  </a:schemeClr>
                </a:solidFill>
              </a:rPr>
              <a:t>47</a:t>
            </a:r>
            <a:endParaRPr lang="es-MX" sz="800" dirty="0">
              <a:solidFill>
                <a:schemeClr val="accent1">
                  <a:lumMod val="75000"/>
                </a:schemeClr>
              </a:solidFill>
            </a:endParaRPr>
          </a:p>
        </p:txBody>
      </p:sp>
      <p:cxnSp>
        <p:nvCxnSpPr>
          <p:cNvPr id="127" name="126 Conector recto de flecha"/>
          <p:cNvCxnSpPr/>
          <p:nvPr/>
        </p:nvCxnSpPr>
        <p:spPr>
          <a:xfrm>
            <a:off x="7357911" y="1591300"/>
            <a:ext cx="467346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127 Conector recto de flecha"/>
          <p:cNvCxnSpPr/>
          <p:nvPr/>
        </p:nvCxnSpPr>
        <p:spPr>
          <a:xfrm>
            <a:off x="4283968" y="1823264"/>
            <a:ext cx="504056" cy="0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30" name="3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6237425"/>
              </p:ext>
            </p:extLst>
          </p:nvPr>
        </p:nvGraphicFramePr>
        <p:xfrm>
          <a:off x="1171029" y="1482999"/>
          <a:ext cx="7024520" cy="38545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32" name="131 Conector recto"/>
          <p:cNvCxnSpPr/>
          <p:nvPr/>
        </p:nvCxnSpPr>
        <p:spPr>
          <a:xfrm>
            <a:off x="1547664" y="4077072"/>
            <a:ext cx="6518438" cy="0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72510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04&quot;&gt;&lt;property id=&quot;20148&quot; value=&quot;5&quot;/&gt;&lt;property id=&quot;20300&quot; value=&quot;Diapositiva 2&quot;/&gt;&lt;property id=&quot;20307&quot; value=&quot;256&quot;/&gt;&lt;/object&gt;&lt;object type=&quot;3&quot; unique_id=&quot;10005&quot;&gt;&lt;property id=&quot;20148&quot; value=&quot;5&quot;/&gt;&lt;property id=&quot;20300&quot; value=&quot;Diapositiva 4&quot;/&gt;&lt;property id=&quot;20307&quot; value=&quot;257&quot;/&gt;&lt;/object&gt;&lt;object type=&quot;3&quot; unique_id=&quot;10006&quot;&gt;&lt;property id=&quot;20148&quot; value=&quot;5&quot;/&gt;&lt;property id=&quot;20300&quot; value=&quot;Diapositiva 1&quot;/&gt;&lt;property id=&quot;20307&quot; value=&quot;258&quot;/&gt;&lt;/object&gt;&lt;object type=&quot;3&quot; unique_id=&quot;10007&quot;&gt;&lt;property id=&quot;20148&quot; value=&quot;5&quot;/&gt;&lt;property id=&quot;20300&quot; value=&quot;Diapositiva 5&quot;/&gt;&lt;property id=&quot;20307&quot; value=&quot;259&quot;/&gt;&lt;/object&gt;&lt;object type=&quot;3&quot; unique_id=&quot;10020&quot;&gt;&lt;property id=&quot;20148&quot; value=&quot;5&quot;/&gt;&lt;property id=&quot;20300&quot; value=&quot;Diapositiva 3&quot;/&gt;&lt;property id=&quot;20307&quot; value=&quot;261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25</TotalTime>
  <Words>72</Words>
  <Application>Microsoft Office PowerPoint</Application>
  <PresentationFormat>Presentación en pantalla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ilia Gonzalez Ceron</dc:creator>
  <cp:lastModifiedBy>Lilia Gonzalez Ceron</cp:lastModifiedBy>
  <cp:revision>125</cp:revision>
  <dcterms:created xsi:type="dcterms:W3CDTF">2010-07-26T17:16:47Z</dcterms:created>
  <dcterms:modified xsi:type="dcterms:W3CDTF">2013-03-19T22:50:54Z</dcterms:modified>
</cp:coreProperties>
</file>